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26.pct" ContentType="image/x-pict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20.png" ContentType="image/png"/>
  <Override PartName="/ppt/media/image6.jpeg" ContentType="image/jpeg"/>
  <Override PartName="/ppt/media/image5.jpeg" ContentType="image/jpeg"/>
  <Override PartName="/ppt/media/image4.jpeg" ContentType="image/jpeg"/>
  <Override PartName="/ppt/media/image25.jpeg" ContentType="image/jpeg"/>
  <Override PartName="/ppt/media/image3.jpeg" ContentType="image/jpeg"/>
  <Override PartName="/ppt/media/image24.jpeg" ContentType="image/jpeg"/>
  <Override PartName="/ppt/media/image27.pct" ContentType="image/x-pict"/>
  <Override PartName="/ppt/media/image15.jpeg" ContentType="image/jpeg"/>
  <Override PartName="/ppt/media/image21.jpeg" ContentType="image/jpeg"/>
  <Override PartName="/ppt/media/image16.jpeg" ContentType="image/jpeg"/>
  <Override PartName="/ppt/media/image19.jpeg" ContentType="image/jpeg"/>
  <Override PartName="/ppt/media/image18.jpeg" ContentType="image/jpeg"/>
  <Override PartName="/ppt/media/image17.jpeg" ContentType="image/jpeg"/>
  <Override PartName="/ppt/media/image1.jpeg" ContentType="image/jpeg"/>
  <Override PartName="/ppt/media/image22.jpeg" ContentType="image/jpeg"/>
  <Override PartName="/ppt/media/image14.jpeg" ContentType="image/jpeg"/>
  <Override PartName="/ppt/media/image23.jpeg" ContentType="image/jpeg"/>
  <Override PartName="/ppt/media/image28.pct" ContentType="image/x-pict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CC5BA5-295A-4E90-BFEA-DED2E9702F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14512D-AB72-4C34-85B2-0B5586F975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DA8855-E8E5-4AFA-9476-7BEFBDA72E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345DF-163A-4EE4-B1A6-5C91A46B62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0290DB-4319-48B7-8294-F72A7BC31D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C8D849-21D0-44BF-86B9-4ACF2DDDE0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6B5657-DC50-40E9-BB85-F4A278F00A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92A9B-00A9-478B-8F63-BE904E610F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57A556-05CA-4528-9DA8-3248F98639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0A8EB0-D713-47FA-88A2-049752183B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8C648-BE4C-471A-8B0D-F4F643EA52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A39695-75A5-4F50-AA6A-36C448924D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230717-1C4C-4225-BA5B-DFDF2838821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pn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image" Target="../media/image26.pct"/><Relationship Id="rId27" Type="http://schemas.openxmlformats.org/officeDocument/2006/relationships/image" Target="../media/image27.pct"/><Relationship Id="rId28" Type="http://schemas.openxmlformats.org/officeDocument/2006/relationships/image" Target="../media/image27.pct"/><Relationship Id="rId29" Type="http://schemas.openxmlformats.org/officeDocument/2006/relationships/image" Target="../media/image27.pct"/><Relationship Id="rId30" Type="http://schemas.openxmlformats.org/officeDocument/2006/relationships/image" Target="../media/image27.pct"/><Relationship Id="rId31" Type="http://schemas.openxmlformats.org/officeDocument/2006/relationships/image" Target="../media/image27.pct"/><Relationship Id="rId32" Type="http://schemas.openxmlformats.org/officeDocument/2006/relationships/image" Target="../media/image27.pct"/><Relationship Id="rId33" Type="http://schemas.openxmlformats.org/officeDocument/2006/relationships/image" Target="../media/image28.pct"/><Relationship Id="rId34" Type="http://schemas.openxmlformats.org/officeDocument/2006/relationships/image" Target="../media/image28.pct"/><Relationship Id="rId35" Type="http://schemas.openxmlformats.org/officeDocument/2006/relationships/image" Target="../media/image28.pct"/><Relationship Id="rId3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94320" y="528480"/>
            <a:ext cx="951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eGFP alon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0" t="25024" r="45235" b="31837"/>
          <a:stretch/>
        </p:blipFill>
        <p:spPr>
          <a:xfrm>
            <a:off x="3054240" y="2614680"/>
            <a:ext cx="862200" cy="8636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rcRect l="0" t="25025" r="45233" b="31835"/>
          <a:stretch/>
        </p:blipFill>
        <p:spPr>
          <a:xfrm>
            <a:off x="3967200" y="2612880"/>
            <a:ext cx="863640" cy="86544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3"/>
          <a:srcRect l="0" t="25024" r="45235" b="31837"/>
          <a:stretch/>
        </p:blipFill>
        <p:spPr>
          <a:xfrm>
            <a:off x="4879800" y="2612880"/>
            <a:ext cx="863640" cy="86544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954360" y="2949480"/>
            <a:ext cx="923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FP-Vpr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A6-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4"/>
          <a:srcRect l="48335" t="30066" r="5204" b="30066"/>
          <a:stretch/>
        </p:blipFill>
        <p:spPr>
          <a:xfrm>
            <a:off x="1957320" y="2612880"/>
            <a:ext cx="862200" cy="86544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5"/>
          <a:srcRect l="6644" t="16609" r="48557" b="36931"/>
          <a:stretch/>
        </p:blipFill>
        <p:spPr>
          <a:xfrm>
            <a:off x="3054240" y="1698480"/>
            <a:ext cx="862200" cy="86364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6"/>
          <a:srcRect l="6644" t="16609" r="48557" b="36931"/>
          <a:stretch/>
        </p:blipFill>
        <p:spPr>
          <a:xfrm>
            <a:off x="3967200" y="169848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7"/>
          <a:srcRect l="6644" t="16609" r="48557" b="36931"/>
          <a:stretch/>
        </p:blipFill>
        <p:spPr>
          <a:xfrm>
            <a:off x="4879800" y="1698480"/>
            <a:ext cx="863640" cy="8636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055880" y="2077920"/>
            <a:ext cx="909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FP-Vpr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1-9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8"/>
          <a:srcRect l="13509" t="16830" r="36709" b="38370"/>
          <a:stretch/>
        </p:blipFill>
        <p:spPr>
          <a:xfrm>
            <a:off x="1957320" y="1698480"/>
            <a:ext cx="862200" cy="86364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954360" y="3863880"/>
            <a:ext cx="923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FP-Vpr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A6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9"/>
          <a:srcRect l="11848" t="11848" r="30066" b="41692"/>
          <a:stretch/>
        </p:blipFill>
        <p:spPr>
          <a:xfrm>
            <a:off x="1957320" y="3529080"/>
            <a:ext cx="862200" cy="86364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954360" y="4778280"/>
            <a:ext cx="923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FP-Vpr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A6-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0"/>
          <a:srcRect l="41692" t="6865" r="18491" b="46675"/>
          <a:stretch/>
        </p:blipFill>
        <p:spPr>
          <a:xfrm>
            <a:off x="1957320" y="4443480"/>
            <a:ext cx="862200" cy="86364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11"/>
          <a:srcRect l="21591" t="26574" r="31948" b="20322"/>
          <a:stretch/>
        </p:blipFill>
        <p:spPr>
          <a:xfrm>
            <a:off x="3054240" y="3529080"/>
            <a:ext cx="862200" cy="86364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12"/>
          <a:srcRect l="21591" t="26574" r="31948" b="20322"/>
          <a:stretch/>
        </p:blipFill>
        <p:spPr>
          <a:xfrm>
            <a:off x="3967200" y="352908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13"/>
          <a:srcRect l="21591" t="26574" r="31948" b="20322"/>
          <a:stretch/>
        </p:blipFill>
        <p:spPr>
          <a:xfrm>
            <a:off x="4879800" y="352908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14"/>
          <a:srcRect l="0" t="19931" r="63062" b="38592"/>
          <a:stretch/>
        </p:blipFill>
        <p:spPr>
          <a:xfrm>
            <a:off x="4879800" y="78408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15"/>
          <a:srcRect l="0" t="19931" r="63062" b="38592"/>
          <a:stretch/>
        </p:blipFill>
        <p:spPr>
          <a:xfrm>
            <a:off x="3967200" y="78408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16"/>
          <a:srcRect l="0" t="19931" r="63062" b="38592"/>
          <a:stretch/>
        </p:blipFill>
        <p:spPr>
          <a:xfrm>
            <a:off x="3054240" y="784080"/>
            <a:ext cx="862200" cy="86364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17"/>
          <a:srcRect l="20100" t="21761" r="36709" b="36709"/>
          <a:stretch/>
        </p:blipFill>
        <p:spPr>
          <a:xfrm>
            <a:off x="1957320" y="784080"/>
            <a:ext cx="862200" cy="86364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1503000" y="1117440"/>
            <a:ext cx="468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197160" y="528480"/>
            <a:ext cx="54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eGF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988080" y="528480"/>
            <a:ext cx="805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-adap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991760" y="528480"/>
            <a:ext cx="59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18"/>
          <a:srcRect l="17834" t="0" r="42039" b="62427"/>
          <a:stretch/>
        </p:blipFill>
        <p:spPr>
          <a:xfrm>
            <a:off x="3054240" y="5351400"/>
            <a:ext cx="862200" cy="86508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19"/>
          <a:srcRect l="17834" t="0" r="42039" b="62427"/>
          <a:stretch/>
        </p:blipFill>
        <p:spPr>
          <a:xfrm>
            <a:off x="3967200" y="5351400"/>
            <a:ext cx="863640" cy="86508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20"/>
          <a:srcRect l="17949" t="0" r="43590" b="64103"/>
          <a:stretch/>
        </p:blipFill>
        <p:spPr>
          <a:xfrm>
            <a:off x="4879800" y="5351400"/>
            <a:ext cx="863640" cy="86508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21"/>
          <a:srcRect l="2215" t="32169" r="63342" b="38813"/>
          <a:stretch/>
        </p:blipFill>
        <p:spPr>
          <a:xfrm>
            <a:off x="1957320" y="5351400"/>
            <a:ext cx="862200" cy="865080"/>
          </a:xfrm>
          <a:prstGeom prst="rect">
            <a:avLst/>
          </a:prstGeom>
          <a:ln w="0">
            <a:noFill/>
          </a:ln>
        </p:spPr>
      </p:pic>
      <p:sp>
        <p:nvSpPr>
          <p:cNvPr id="71" name=""/>
          <p:cNvSpPr/>
          <p:nvPr/>
        </p:nvSpPr>
        <p:spPr>
          <a:xfrm>
            <a:off x="1029600" y="5688000"/>
            <a:ext cx="934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FP-Vpr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F72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22"/>
          <a:srcRect l="51273" t="26744" r="7810" b="42024"/>
          <a:stretch/>
        </p:blipFill>
        <p:spPr>
          <a:xfrm>
            <a:off x="3967200" y="6267600"/>
            <a:ext cx="863640" cy="863280"/>
          </a:xfrm>
          <a:prstGeom prst="rect">
            <a:avLst/>
          </a:prstGeom>
          <a:ln w="0">
            <a:noFill/>
          </a:ln>
        </p:spPr>
      </p:pic>
      <p:sp>
        <p:nvSpPr>
          <p:cNvPr id="73" name=""/>
          <p:cNvSpPr/>
          <p:nvPr/>
        </p:nvSpPr>
        <p:spPr>
          <a:xfrm>
            <a:off x="1177560" y="6526080"/>
            <a:ext cx="8056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-adap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lon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23"/>
          <a:srcRect l="38208" t="26574" r="28626" b="38592"/>
          <a:stretch/>
        </p:blipFill>
        <p:spPr>
          <a:xfrm>
            <a:off x="3054240" y="444348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24"/>
          <a:srcRect l="38208" t="26574" r="28626" b="38592"/>
          <a:stretch/>
        </p:blipFill>
        <p:spPr>
          <a:xfrm>
            <a:off x="3967200" y="444348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25"/>
          <a:srcRect l="38208" t="26574" r="28626" b="38592"/>
          <a:stretch/>
        </p:blipFill>
        <p:spPr>
          <a:xfrm>
            <a:off x="4879800" y="444348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77" name="" descr=""/>
          <p:cNvPicPr/>
          <p:nvPr/>
        </p:nvPicPr>
        <p:blipFill>
          <a:blip r:embed="rId26"/>
          <a:stretch/>
        </p:blipFill>
        <p:spPr>
          <a:xfrm flipH="1">
            <a:off x="4495320" y="6686640"/>
            <a:ext cx="304920" cy="9504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>
            <a:off x="4805280" y="66088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olg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" descr=""/>
          <p:cNvPicPr/>
          <p:nvPr/>
        </p:nvPicPr>
        <p:blipFill>
          <a:blip r:embed="rId27"/>
          <a:stretch/>
        </p:blipFill>
        <p:spPr>
          <a:xfrm>
            <a:off x="4413240" y="5819760"/>
            <a:ext cx="162000" cy="171360"/>
          </a:xfrm>
          <a:prstGeom prst="rect">
            <a:avLst/>
          </a:prstGeom>
          <a:ln w="0">
            <a:noFill/>
          </a:ln>
        </p:spPr>
      </p:pic>
      <p:pic>
        <p:nvPicPr>
          <p:cNvPr id="80" name="" descr=""/>
          <p:cNvPicPr/>
          <p:nvPr/>
        </p:nvPicPr>
        <p:blipFill>
          <a:blip r:embed="rId28"/>
          <a:stretch/>
        </p:blipFill>
        <p:spPr>
          <a:xfrm>
            <a:off x="3492360" y="5819760"/>
            <a:ext cx="162000" cy="171360"/>
          </a:xfrm>
          <a:prstGeom prst="rect">
            <a:avLst/>
          </a:prstGeom>
          <a:ln w="0">
            <a:noFill/>
          </a:ln>
        </p:spPr>
      </p:pic>
      <p:pic>
        <p:nvPicPr>
          <p:cNvPr id="81" name="" descr=""/>
          <p:cNvPicPr/>
          <p:nvPr/>
        </p:nvPicPr>
        <p:blipFill>
          <a:blip r:embed="rId29"/>
          <a:stretch/>
        </p:blipFill>
        <p:spPr>
          <a:xfrm>
            <a:off x="5308560" y="5819760"/>
            <a:ext cx="162000" cy="171360"/>
          </a:xfrm>
          <a:prstGeom prst="rect">
            <a:avLst/>
          </a:prstGeom>
          <a:ln w="0">
            <a:noFill/>
          </a:ln>
        </p:spPr>
      </p:pic>
      <p:pic>
        <p:nvPicPr>
          <p:cNvPr id="82" name="" descr=""/>
          <p:cNvPicPr/>
          <p:nvPr/>
        </p:nvPicPr>
        <p:blipFill>
          <a:blip r:embed="rId30"/>
          <a:stretch/>
        </p:blipFill>
        <p:spPr>
          <a:xfrm>
            <a:off x="4495680" y="3921120"/>
            <a:ext cx="162000" cy="171360"/>
          </a:xfrm>
          <a:prstGeom prst="rect">
            <a:avLst/>
          </a:prstGeom>
          <a:ln w="0">
            <a:noFill/>
          </a:ln>
        </p:spPr>
      </p:pic>
      <p:pic>
        <p:nvPicPr>
          <p:cNvPr id="83" name="" descr=""/>
          <p:cNvPicPr/>
          <p:nvPr/>
        </p:nvPicPr>
        <p:blipFill>
          <a:blip r:embed="rId31"/>
          <a:stretch/>
        </p:blipFill>
        <p:spPr>
          <a:xfrm>
            <a:off x="3575160" y="3921120"/>
            <a:ext cx="161640" cy="17136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32"/>
          <a:stretch/>
        </p:blipFill>
        <p:spPr>
          <a:xfrm>
            <a:off x="5391000" y="3921120"/>
            <a:ext cx="162000" cy="17136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33"/>
          <a:stretch/>
        </p:blipFill>
        <p:spPr>
          <a:xfrm>
            <a:off x="3540240" y="2741760"/>
            <a:ext cx="183960" cy="182520"/>
          </a:xfrm>
          <a:prstGeom prst="rect">
            <a:avLst/>
          </a:prstGeom>
          <a:ln w="0">
            <a:noFill/>
          </a:ln>
        </p:spPr>
      </p:pic>
      <p:pic>
        <p:nvPicPr>
          <p:cNvPr id="86" name="" descr=""/>
          <p:cNvPicPr/>
          <p:nvPr/>
        </p:nvPicPr>
        <p:blipFill>
          <a:blip r:embed="rId34"/>
          <a:stretch/>
        </p:blipFill>
        <p:spPr>
          <a:xfrm>
            <a:off x="4435560" y="2735280"/>
            <a:ext cx="183960" cy="182520"/>
          </a:xfrm>
          <a:prstGeom prst="rect">
            <a:avLst/>
          </a:prstGeom>
          <a:ln w="0">
            <a:noFill/>
          </a:ln>
        </p:spPr>
      </p:pic>
      <p:pic>
        <p:nvPicPr>
          <p:cNvPr id="87" name="" descr=""/>
          <p:cNvPicPr/>
          <p:nvPr/>
        </p:nvPicPr>
        <p:blipFill>
          <a:blip r:embed="rId35"/>
          <a:stretch/>
        </p:blipFill>
        <p:spPr>
          <a:xfrm>
            <a:off x="5337000" y="2735280"/>
            <a:ext cx="184320" cy="182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10T04:44:42Z</dcterms:created>
  <dc:creator>Leon Caly</dc:creator>
  <dc:description/>
  <dc:language>en-US</dc:language>
  <cp:lastModifiedBy>Leon Caly</cp:lastModifiedBy>
  <dcterms:modified xsi:type="dcterms:W3CDTF">2008-07-10T04:46:01Z</dcterms:modified>
  <cp:revision>1</cp:revision>
  <dc:subject/>
  <dc:title>PowerPoint Presentation</dc:title>
</cp:coreProperties>
</file>